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32586-8805-4A64-A8E3-2B949FFF1A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6E4023-8F3D-4856-8D0E-D6DE83D22D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468EC-62CC-486A-BCE5-C15853C483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F121B-24B1-467E-931E-E6BCEB875E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9C96A5-75F0-49CC-9CAE-B0DD0D2FA6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AFC53-4219-444C-B564-A0F34B7EA9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8E16B6-2E6C-4199-A732-CA4635231E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FC1302-8E3D-45B1-9A8B-4A1C27CCBD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88E7B-DFAE-425F-ABF0-342542A9B2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F27E3-F50A-4273-9B70-014584A9DC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0D534-6929-443F-8AAD-3206644D22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6D259-1D50-456B-8759-EAA7E8D0A2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45D7C0-B16B-4AFC-AB11-408812C3B009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</a:rPr>
              <a:t>Supplement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图片 9" descr=""/>
          <p:cNvPicPr/>
          <p:nvPr/>
        </p:nvPicPr>
        <p:blipFill>
          <a:blip r:embed="rId1"/>
          <a:stretch/>
        </p:blipFill>
        <p:spPr>
          <a:xfrm>
            <a:off x="336600" y="1417680"/>
            <a:ext cx="8470800" cy="3483000"/>
          </a:xfrm>
          <a:prstGeom prst="rect">
            <a:avLst/>
          </a:prstGeom>
          <a:ln w="0">
            <a:noFill/>
          </a:ln>
        </p:spPr>
      </p:pic>
      <p:sp>
        <p:nvSpPr>
          <p:cNvPr id="43" name="文本框 10"/>
          <p:cNvSpPr/>
          <p:nvPr/>
        </p:nvSpPr>
        <p:spPr>
          <a:xfrm>
            <a:off x="684360" y="5084640"/>
            <a:ext cx="8073720" cy="100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Figure 1. Diversity in the intestinal ecosystem.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e intestinal microbiota diversity at engraftment time was estimated as observed operational taxonomic units (OTUs) (A) and Shannon index (B)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2-21T22:11:20Z</dcterms:created>
  <dc:creator>Administrator</dc:creator>
  <dc:description/>
  <dc:language>en-US</dc:language>
  <cp:lastModifiedBy>Administrator</cp:lastModifiedBy>
  <dcterms:modified xsi:type="dcterms:W3CDTF">2018-01-01T00:18:04Z</dcterms:modified>
  <cp:revision>4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KSOProductBuildVer">
    <vt:lpwstr>2052-8.1.0.2424</vt:lpwstr>
  </property>
  <property fmtid="{D5CDD505-2E9C-101B-9397-08002B2CF9AE}" pid="6" name="TitleName">
    <vt:lpwstr>Presentation 1.PPT</vt:lpwstr>
  </property>
</Properties>
</file>